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306" r:id="rId2"/>
    <p:sldId id="289" r:id="rId3"/>
    <p:sldId id="282" r:id="rId4"/>
    <p:sldId id="284" r:id="rId5"/>
    <p:sldId id="317" r:id="rId6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5930" autoAdjust="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C0EF96-14C4-4A1A-8DB7-840D8EDAEFD7}" type="datetimeFigureOut">
              <a:rPr lang="de-DE" smtClean="0"/>
              <a:t>27.08.2024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2C75EB-B291-41D9-8A7D-E975048EA83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759957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60F58-9895-4B18-A981-C0CEB5D467F6}" type="datetimeFigureOut">
              <a:rPr lang="de-DE" smtClean="0"/>
              <a:t>27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7CFFE-8129-499C-9D56-20253B621F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91623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60F58-9895-4B18-A981-C0CEB5D467F6}" type="datetimeFigureOut">
              <a:rPr lang="de-DE" smtClean="0"/>
              <a:t>27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7CFFE-8129-499C-9D56-20253B621F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2861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60F58-9895-4B18-A981-C0CEB5D467F6}" type="datetimeFigureOut">
              <a:rPr lang="de-DE" smtClean="0"/>
              <a:t>27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7CFFE-8129-499C-9D56-20253B621F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89398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60F58-9895-4B18-A981-C0CEB5D467F6}" type="datetimeFigureOut">
              <a:rPr lang="de-DE" smtClean="0"/>
              <a:t>27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7CFFE-8129-499C-9D56-20253B621F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160815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60F58-9895-4B18-A981-C0CEB5D467F6}" type="datetimeFigureOut">
              <a:rPr lang="de-DE" smtClean="0"/>
              <a:t>27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7CFFE-8129-499C-9D56-20253B621F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27572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60F58-9895-4B18-A981-C0CEB5D467F6}" type="datetimeFigureOut">
              <a:rPr lang="de-DE" smtClean="0"/>
              <a:t>27.08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7CFFE-8129-499C-9D56-20253B621F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06175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60F58-9895-4B18-A981-C0CEB5D467F6}" type="datetimeFigureOut">
              <a:rPr lang="de-DE" smtClean="0"/>
              <a:t>27.08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7CFFE-8129-499C-9D56-20253B621F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817400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60F58-9895-4B18-A981-C0CEB5D467F6}" type="datetimeFigureOut">
              <a:rPr lang="de-DE" smtClean="0"/>
              <a:t>27.08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7CFFE-8129-499C-9D56-20253B621F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63038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60F58-9895-4B18-A981-C0CEB5D467F6}" type="datetimeFigureOut">
              <a:rPr lang="de-DE" smtClean="0"/>
              <a:t>27.08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7CFFE-8129-499C-9D56-20253B621F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804120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60F58-9895-4B18-A981-C0CEB5D467F6}" type="datetimeFigureOut">
              <a:rPr lang="de-DE" smtClean="0"/>
              <a:t>27.08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7CFFE-8129-499C-9D56-20253B621F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0381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60F58-9895-4B18-A981-C0CEB5D467F6}" type="datetimeFigureOut">
              <a:rPr lang="de-DE" smtClean="0"/>
              <a:t>27.08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7CFFE-8129-499C-9D56-20253B621F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293563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B60F58-9895-4B18-A981-C0CEB5D467F6}" type="datetimeFigureOut">
              <a:rPr lang="de-DE" smtClean="0"/>
              <a:t>27.08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47CFFE-8129-499C-9D56-20253B621F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969929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741714"/>
            <a:ext cx="12089304" cy="3207505"/>
          </a:xfrm>
          <a:prstGeom prst="rect">
            <a:avLst/>
          </a:prstGeom>
        </p:spPr>
      </p:pic>
      <p:sp>
        <p:nvSpPr>
          <p:cNvPr id="6" name="Textfeld 5"/>
          <p:cNvSpPr txBox="1"/>
          <p:nvPr/>
        </p:nvSpPr>
        <p:spPr>
          <a:xfrm>
            <a:off x="130628" y="6010159"/>
            <a:ext cx="21719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de-DE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11189326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5835" y="140162"/>
            <a:ext cx="11409506" cy="6343765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245835" y="6393335"/>
            <a:ext cx="22412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de-DE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2</a:t>
            </a:r>
            <a:endParaRPr lang="de-DE" sz="2000" b="1" dirty="0"/>
          </a:p>
        </p:txBody>
      </p:sp>
    </p:spTree>
    <p:extLst>
      <p:ext uri="{BB962C8B-B14F-4D97-AF65-F5344CB8AC3E}">
        <p14:creationId xmlns:p14="http://schemas.microsoft.com/office/powerpoint/2010/main" val="41415824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1DAAD-E383-4827-898C-D02782AB438A}" type="slidenum">
              <a:rPr lang="de-DE" smtClean="0"/>
              <a:t>3</a:t>
            </a:fld>
            <a:endParaRPr lang="de-DE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1217" y="316069"/>
            <a:ext cx="11558776" cy="5835349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311217" y="6356350"/>
            <a:ext cx="21743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de-DE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3</a:t>
            </a:r>
            <a:endParaRPr lang="de-DE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81569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1491" y="307916"/>
            <a:ext cx="11624323" cy="5868440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251491" y="6331415"/>
            <a:ext cx="22130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de-DE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4</a:t>
            </a:r>
            <a:endParaRPr lang="de-DE" sz="2000" b="1" dirty="0"/>
          </a:p>
        </p:txBody>
      </p:sp>
    </p:spTree>
    <p:extLst>
      <p:ext uri="{BB962C8B-B14F-4D97-AF65-F5344CB8AC3E}">
        <p14:creationId xmlns:p14="http://schemas.microsoft.com/office/powerpoint/2010/main" val="41823752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89459471"/>
              </p:ext>
            </p:extLst>
          </p:nvPr>
        </p:nvGraphicFramePr>
        <p:xfrm>
          <a:off x="-74814" y="1172529"/>
          <a:ext cx="6234545" cy="43803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83" name="Prism 9" r:id="rId3" imgW="4141634" imgH="2953125" progId="Prism9.Document">
                  <p:embed/>
                </p:oleObj>
              </mc:Choice>
              <mc:Fallback>
                <p:oleObj name="Prism 9" r:id="rId3" imgW="4141634" imgH="2953125" progId="Prism9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-74814" y="1172529"/>
                        <a:ext cx="6234545" cy="438037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feld 4"/>
          <p:cNvSpPr txBox="1"/>
          <p:nvPr/>
        </p:nvSpPr>
        <p:spPr>
          <a:xfrm>
            <a:off x="252153" y="5766744"/>
            <a:ext cx="22749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de-DE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5</a:t>
            </a:r>
            <a:endParaRPr lang="de-DE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Grafik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53369" y="1172529"/>
            <a:ext cx="5796820" cy="43803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59338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</Words>
  <Application>Microsoft Office PowerPoint</Application>
  <PresentationFormat>Breitbild</PresentationFormat>
  <Paragraphs>6</Paragraphs>
  <Slides>5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</vt:lpstr>
      <vt:lpstr>Prism 9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niversitätsmedizin Mainz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uffy, Maximilian</dc:creator>
  <cp:lastModifiedBy>Luffy, Maximilian</cp:lastModifiedBy>
  <cp:revision>133</cp:revision>
  <dcterms:created xsi:type="dcterms:W3CDTF">2024-05-10T08:16:45Z</dcterms:created>
  <dcterms:modified xsi:type="dcterms:W3CDTF">2024-08-27T08:25:00Z</dcterms:modified>
</cp:coreProperties>
</file>